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720" userDrawn="1">
          <p15:clr>
            <a:srgbClr val="A4A3A4"/>
          </p15:clr>
        </p15:guide>
        <p15:guide id="4" pos="3600" userDrawn="1">
          <p15:clr>
            <a:srgbClr val="A4A3A4"/>
          </p15:clr>
        </p15:guide>
        <p15:guide id="5" pos="3504" userDrawn="1">
          <p15:clr>
            <a:srgbClr val="A4A3A4"/>
          </p15:clr>
        </p15:guide>
        <p15:guide id="6" pos="10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EBE6"/>
    <a:srgbClr val="F6B600"/>
    <a:srgbClr val="FF7C5D"/>
    <a:srgbClr val="FF5A33"/>
    <a:srgbClr val="0033CC"/>
    <a:srgbClr val="CC9900"/>
    <a:srgbClr val="009999"/>
    <a:srgbClr val="33CC33"/>
    <a:srgbClr val="FF3300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236" y="108"/>
      </p:cViewPr>
      <p:guideLst>
        <p:guide orient="horz" pos="2880"/>
        <p:guide pos="2160"/>
        <p:guide pos="720"/>
        <p:guide pos="3600"/>
        <p:guide pos="3504"/>
        <p:guide pos="10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manishkpatel\Downloads\Root%20length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manishkpatel\Downloads\fresh%20weigh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132390612408423E-2"/>
          <c:y val="5.0925925925925923E-2"/>
          <c:w val="0.88942324747999979"/>
          <c:h val="0.72520778413740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NAL!$J$16:$S$16</c:f>
              <c:strCache>
                <c:ptCount val="1"/>
                <c:pt idx="0">
                  <c:v>Root Length Shoot Length</c:v>
                </c:pt>
              </c:strCache>
            </c:strRef>
          </c:tx>
          <c:spPr>
            <a:solidFill>
              <a:srgbClr val="808000"/>
            </a:solidFill>
          </c:spPr>
          <c:invertIfNegative val="0"/>
          <c:dPt>
            <c:idx val="5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9"/>
            <c:invertIfNegative val="0"/>
            <c:bubble3D val="0"/>
            <c:spPr>
              <a:solidFill>
                <a:srgbClr val="008000"/>
              </a:solidFill>
            </c:spPr>
          </c:dPt>
          <c:errBars>
            <c:errBarType val="both"/>
            <c:errValType val="fixedVal"/>
            <c:noEndCap val="0"/>
            <c:val val="0.1"/>
          </c:errBars>
          <c:cat>
            <c:multiLvlStrRef>
              <c:f>FINAL!$J$16:$S$17</c:f>
              <c:multiLvlStrCache>
                <c:ptCount val="10"/>
                <c:lvl>
                  <c:pt idx="0">
                    <c:v>0 mM</c:v>
                  </c:pt>
                  <c:pt idx="1">
                    <c:v>30 mM</c:v>
                  </c:pt>
                  <c:pt idx="2">
                    <c:v>50 mM</c:v>
                  </c:pt>
                  <c:pt idx="3">
                    <c:v>80 mM</c:v>
                  </c:pt>
                  <c:pt idx="4">
                    <c:v>100 mM</c:v>
                  </c:pt>
                  <c:pt idx="5">
                    <c:v>0 mM</c:v>
                  </c:pt>
                  <c:pt idx="6">
                    <c:v>30 mM</c:v>
                  </c:pt>
                  <c:pt idx="7">
                    <c:v>50 mM</c:v>
                  </c:pt>
                  <c:pt idx="8">
                    <c:v>80 mM</c:v>
                  </c:pt>
                  <c:pt idx="9">
                    <c:v>100 mM</c:v>
                  </c:pt>
                </c:lvl>
                <c:lvl>
                  <c:pt idx="0">
                    <c:v>Root Length</c:v>
                  </c:pt>
                  <c:pt idx="5">
                    <c:v>Shoot Length</c:v>
                  </c:pt>
                </c:lvl>
              </c:multiLvlStrCache>
            </c:multiLvlStrRef>
          </c:cat>
          <c:val>
            <c:numRef>
              <c:f>FINAL!$J$18:$S$18</c:f>
              <c:numCache>
                <c:formatCode>General</c:formatCode>
                <c:ptCount val="10"/>
                <c:pt idx="0">
                  <c:v>7.8199999999999985</c:v>
                </c:pt>
                <c:pt idx="1">
                  <c:v>6.04</c:v>
                </c:pt>
                <c:pt idx="2">
                  <c:v>4.42</c:v>
                </c:pt>
                <c:pt idx="3">
                  <c:v>2.17</c:v>
                </c:pt>
                <c:pt idx="4">
                  <c:v>0.74000000000000044</c:v>
                </c:pt>
                <c:pt idx="5">
                  <c:v>4.4300000000000024</c:v>
                </c:pt>
                <c:pt idx="6">
                  <c:v>3.53</c:v>
                </c:pt>
                <c:pt idx="7">
                  <c:v>2.88</c:v>
                </c:pt>
                <c:pt idx="8">
                  <c:v>1.1200000000000001</c:v>
                </c:pt>
                <c:pt idx="9">
                  <c:v>0.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01232880"/>
        <c:axId val="-901231248"/>
      </c:barChart>
      <c:catAx>
        <c:axId val="-901232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901231248"/>
        <c:crosses val="autoZero"/>
        <c:auto val="1"/>
        <c:lblAlgn val="ctr"/>
        <c:lblOffset val="100"/>
        <c:noMultiLvlLbl val="0"/>
      </c:catAx>
      <c:valAx>
        <c:axId val="-901231248"/>
        <c:scaling>
          <c:orientation val="minMax"/>
          <c:max val="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901232880"/>
        <c:crosses val="autoZero"/>
        <c:crossBetween val="between"/>
        <c:majorUnit val="2"/>
        <c:min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rgbClr val="0000CC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745547180933945"/>
          <c:y val="5.0925925925925923E-2"/>
          <c:w val="0.85830491374758566"/>
          <c:h val="0.729720311889414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NAL!$J$16:$S$16</c:f>
              <c:strCache>
                <c:ptCount val="1"/>
                <c:pt idx="0">
                  <c:v>Fresh Weight Dry Weight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3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008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808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808000"/>
              </a:solidFill>
            </c:spPr>
          </c:dPt>
          <c:dPt>
            <c:idx val="7"/>
            <c:invertIfNegative val="0"/>
            <c:bubble3D val="0"/>
            <c:spPr>
              <a:solidFill>
                <a:srgbClr val="808000"/>
              </a:solidFill>
            </c:spPr>
          </c:dPt>
          <c:dPt>
            <c:idx val="8"/>
            <c:invertIfNegative val="0"/>
            <c:bubble3D val="0"/>
            <c:spPr>
              <a:solidFill>
                <a:srgbClr val="808000"/>
              </a:solidFill>
            </c:spPr>
          </c:dPt>
          <c:dPt>
            <c:idx val="9"/>
            <c:invertIfNegative val="0"/>
            <c:bubble3D val="0"/>
            <c:spPr>
              <a:solidFill>
                <a:srgbClr val="808000"/>
              </a:solidFill>
            </c:spPr>
          </c:dPt>
          <c:errBars>
            <c:errBarType val="both"/>
            <c:errValType val="cust"/>
            <c:noEndCap val="0"/>
            <c:plus>
              <c:numRef>
                <c:f>FINAL!$J$19:$S$19</c:f>
                <c:numCache>
                  <c:formatCode>General</c:formatCode>
                  <c:ptCount val="10"/>
                  <c:pt idx="0">
                    <c:v>1.32</c:v>
                  </c:pt>
                  <c:pt idx="1">
                    <c:v>0.74000000000000066</c:v>
                  </c:pt>
                  <c:pt idx="2">
                    <c:v>0.71000000000000063</c:v>
                  </c:pt>
                  <c:pt idx="3">
                    <c:v>1.07</c:v>
                  </c:pt>
                  <c:pt idx="4">
                    <c:v>0.53</c:v>
                  </c:pt>
                  <c:pt idx="5">
                    <c:v>8.0000000000000043E-2</c:v>
                  </c:pt>
                  <c:pt idx="6">
                    <c:v>3.0000000000000002E-2</c:v>
                  </c:pt>
                  <c:pt idx="7">
                    <c:v>2.0000000000000011E-2</c:v>
                  </c:pt>
                  <c:pt idx="8">
                    <c:v>8.0000000000000043E-2</c:v>
                  </c:pt>
                  <c:pt idx="9">
                    <c:v>4.0000000000000022E-2</c:v>
                  </c:pt>
                </c:numCache>
              </c:numRef>
            </c:plus>
            <c:minus>
              <c:numRef>
                <c:f>FINAL!$J$19:$S$19</c:f>
                <c:numCache>
                  <c:formatCode>General</c:formatCode>
                  <c:ptCount val="10"/>
                  <c:pt idx="0">
                    <c:v>1.32</c:v>
                  </c:pt>
                  <c:pt idx="1">
                    <c:v>0.74000000000000066</c:v>
                  </c:pt>
                  <c:pt idx="2">
                    <c:v>0.71000000000000063</c:v>
                  </c:pt>
                  <c:pt idx="3">
                    <c:v>1.07</c:v>
                  </c:pt>
                  <c:pt idx="4">
                    <c:v>0.53</c:v>
                  </c:pt>
                  <c:pt idx="5">
                    <c:v>8.0000000000000043E-2</c:v>
                  </c:pt>
                  <c:pt idx="6">
                    <c:v>3.0000000000000002E-2</c:v>
                  </c:pt>
                  <c:pt idx="7">
                    <c:v>2.0000000000000011E-2</c:v>
                  </c:pt>
                  <c:pt idx="8">
                    <c:v>8.0000000000000043E-2</c:v>
                  </c:pt>
                  <c:pt idx="9">
                    <c:v>4.0000000000000022E-2</c:v>
                  </c:pt>
                </c:numCache>
              </c:numRef>
            </c:minus>
          </c:errBars>
          <c:cat>
            <c:multiLvlStrRef>
              <c:f>FINAL!$J$16:$S$17</c:f>
              <c:multiLvlStrCache>
                <c:ptCount val="10"/>
                <c:lvl>
                  <c:pt idx="0">
                    <c:v>0 mM</c:v>
                  </c:pt>
                  <c:pt idx="1">
                    <c:v>30 mM</c:v>
                  </c:pt>
                  <c:pt idx="2">
                    <c:v>50 mM</c:v>
                  </c:pt>
                  <c:pt idx="3">
                    <c:v>80 mM</c:v>
                  </c:pt>
                  <c:pt idx="4">
                    <c:v>100 mM</c:v>
                  </c:pt>
                  <c:pt idx="5">
                    <c:v>0 mM</c:v>
                  </c:pt>
                  <c:pt idx="6">
                    <c:v>30 mM</c:v>
                  </c:pt>
                  <c:pt idx="7">
                    <c:v>50 mM</c:v>
                  </c:pt>
                  <c:pt idx="8">
                    <c:v>80 mM</c:v>
                  </c:pt>
                  <c:pt idx="9">
                    <c:v>100 mM</c:v>
                  </c:pt>
                </c:lvl>
                <c:lvl>
                  <c:pt idx="0">
                    <c:v>Fresh Weight</c:v>
                  </c:pt>
                  <c:pt idx="5">
                    <c:v>Dry Weight</c:v>
                  </c:pt>
                </c:lvl>
              </c:multiLvlStrCache>
            </c:multiLvlStrRef>
          </c:cat>
          <c:val>
            <c:numRef>
              <c:f>FINAL!$J$18:$S$18</c:f>
              <c:numCache>
                <c:formatCode>General</c:formatCode>
                <c:ptCount val="10"/>
                <c:pt idx="0">
                  <c:v>26.43</c:v>
                </c:pt>
                <c:pt idx="1">
                  <c:v>20.459999999999987</c:v>
                </c:pt>
                <c:pt idx="2">
                  <c:v>14.76</c:v>
                </c:pt>
                <c:pt idx="3">
                  <c:v>8.4700000000000006</c:v>
                </c:pt>
                <c:pt idx="4">
                  <c:v>2.3499999999999988</c:v>
                </c:pt>
                <c:pt idx="5">
                  <c:v>2.7800000000000002</c:v>
                </c:pt>
                <c:pt idx="6">
                  <c:v>2.13</c:v>
                </c:pt>
                <c:pt idx="7">
                  <c:v>1.75</c:v>
                </c:pt>
                <c:pt idx="8">
                  <c:v>1.41</c:v>
                </c:pt>
                <c:pt idx="9">
                  <c:v>0.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01227984"/>
        <c:axId val="-901227440"/>
      </c:barChart>
      <c:catAx>
        <c:axId val="-901227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901227440"/>
        <c:crosses val="autoZero"/>
        <c:auto val="1"/>
        <c:lblAlgn val="ctr"/>
        <c:lblOffset val="100"/>
        <c:noMultiLvlLbl val="0"/>
      </c:catAx>
      <c:valAx>
        <c:axId val="-901227440"/>
        <c:scaling>
          <c:orientation val="minMax"/>
          <c:max val="3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901227984"/>
        <c:crosses val="autoZero"/>
        <c:crossBetween val="between"/>
        <c:majorUnit val="3"/>
        <c:min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rgbClr val="0000CC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7708</cdr:x>
      <cdr:y>0.62326</cdr:y>
    </cdr:from>
    <cdr:to>
      <cdr:x>0.30833</cdr:x>
      <cdr:y>0.6822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66825" y="1709738"/>
          <a:ext cx="142875" cy="1619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IN" sz="1100"/>
        </a:p>
      </cdr:txBody>
    </cdr:sp>
  </cdr:relSizeAnchor>
  <cdr:relSizeAnchor xmlns:cdr="http://schemas.openxmlformats.org/drawingml/2006/chartDrawing">
    <cdr:from>
      <cdr:x>0.04992</cdr:x>
      <cdr:y>0.30219</cdr:y>
    </cdr:from>
    <cdr:to>
      <cdr:x>0.10764</cdr:x>
      <cdr:y>0.58248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304800" y="985839"/>
          <a:ext cx="352425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IN" sz="1100"/>
        </a:p>
      </cdr:txBody>
    </cdr:sp>
  </cdr:relSizeAnchor>
  <cdr:relSizeAnchor xmlns:cdr="http://schemas.openxmlformats.org/drawingml/2006/chartDrawing">
    <cdr:from>
      <cdr:x>0.27708</cdr:x>
      <cdr:y>0.62326</cdr:y>
    </cdr:from>
    <cdr:to>
      <cdr:x>0.30833</cdr:x>
      <cdr:y>0.68229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266825" y="1709738"/>
          <a:ext cx="142875" cy="1619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IN" sz="1100"/>
        </a:p>
      </cdr:txBody>
    </cdr:sp>
  </cdr:relSizeAnchor>
  <cdr:relSizeAnchor xmlns:cdr="http://schemas.openxmlformats.org/drawingml/2006/chartDrawing">
    <cdr:from>
      <cdr:x>0</cdr:x>
      <cdr:y>0.30883</cdr:y>
    </cdr:from>
    <cdr:to>
      <cdr:x>0.039</cdr:x>
      <cdr:y>0.58912</cdr:y>
    </cdr:to>
    <cdr:sp macro="" textlink="">
      <cdr:nvSpPr>
        <cdr:cNvPr id="7" name="TextBox 3"/>
        <cdr:cNvSpPr txBox="1"/>
      </cdr:nvSpPr>
      <cdr:spPr>
        <a:xfrm xmlns:a="http://schemas.openxmlformats.org/drawingml/2006/main" rot="16200000">
          <a:off x="-812425" y="1291206"/>
          <a:ext cx="873680" cy="2165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IN" sz="1200" b="1" dirty="0">
              <a:latin typeface="Times New Roman" pitchFamily="18" charset="0"/>
              <a:cs typeface="Times New Roman" pitchFamily="18" charset="0"/>
            </a:rPr>
            <a:t>Length</a:t>
          </a:r>
          <a:r>
            <a:rPr lang="en-IN" sz="1200" dirty="0">
              <a:latin typeface="Times New Roman" pitchFamily="18" charset="0"/>
              <a:cs typeface="Times New Roman" pitchFamily="18" charset="0"/>
            </a:rPr>
            <a:t> [cm]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7708</cdr:x>
      <cdr:y>0.62326</cdr:y>
    </cdr:from>
    <cdr:to>
      <cdr:x>0.30833</cdr:x>
      <cdr:y>0.6822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66825" y="1709738"/>
          <a:ext cx="142875" cy="1619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IN" sz="1100"/>
        </a:p>
      </cdr:txBody>
    </cdr:sp>
  </cdr:relSizeAnchor>
  <cdr:relSizeAnchor xmlns:cdr="http://schemas.openxmlformats.org/drawingml/2006/chartDrawing">
    <cdr:from>
      <cdr:x>0</cdr:x>
      <cdr:y>0.28117</cdr:y>
    </cdr:from>
    <cdr:to>
      <cdr:x>0.04677</cdr:x>
      <cdr:y>0.56666</cdr:y>
    </cdr:to>
    <cdr:sp macro="" textlink="">
      <cdr:nvSpPr>
        <cdr:cNvPr id="4" name="TextBox 3"/>
        <cdr:cNvSpPr txBox="1"/>
      </cdr:nvSpPr>
      <cdr:spPr>
        <a:xfrm xmlns:a="http://schemas.openxmlformats.org/drawingml/2006/main" rot="16200000">
          <a:off x="-785898" y="1193400"/>
          <a:ext cx="890569" cy="2579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IN" sz="1200" b="1" dirty="0">
              <a:latin typeface="Times New Roman" pitchFamily="18" charset="0"/>
              <a:cs typeface="Times New Roman" pitchFamily="18" charset="0"/>
            </a:rPr>
            <a:t>Weight</a:t>
          </a:r>
          <a:r>
            <a:rPr lang="en-IN" sz="1200" b="0" baseline="0" dirty="0">
              <a:latin typeface="Times New Roman" pitchFamily="18" charset="0"/>
              <a:cs typeface="Times New Roman" pitchFamily="18" charset="0"/>
            </a:rPr>
            <a:t> [mg]</a:t>
          </a:r>
          <a:endParaRPr lang="en-IN" sz="1200" b="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808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1067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3727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834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7922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4091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03621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6065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1863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8316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7947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3EBC8-4DA8-46FC-AC2E-850628D305C1}" type="datetimeFigureOut">
              <a:rPr lang="en-IN" smtClean="0"/>
              <a:pPr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96590-3CB9-49DE-BA06-9729B1B90A74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61001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69582" y="599026"/>
            <a:ext cx="5567363" cy="6335174"/>
            <a:chOff x="652462" y="599026"/>
            <a:chExt cx="5567363" cy="6335174"/>
          </a:xfrm>
        </p:grpSpPr>
        <p:grpSp>
          <p:nvGrpSpPr>
            <p:cNvPr id="33" name="Group 32"/>
            <p:cNvGrpSpPr/>
            <p:nvPr/>
          </p:nvGrpSpPr>
          <p:grpSpPr>
            <a:xfrm>
              <a:off x="652462" y="599026"/>
              <a:ext cx="5567363" cy="6335174"/>
              <a:chOff x="728662" y="440530"/>
              <a:chExt cx="5567363" cy="6335174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742950" y="3658647"/>
                <a:ext cx="5553075" cy="3117057"/>
                <a:chOff x="714375" y="3668172"/>
                <a:chExt cx="5553075" cy="3117057"/>
              </a:xfrm>
            </p:grpSpPr>
            <p:graphicFrame>
              <p:nvGraphicFramePr>
                <p:cNvPr id="19" name="Chart 18"/>
                <p:cNvGraphicFramePr/>
                <p:nvPr>
                  <p:extLst>
                    <p:ext uri="{D42A27DB-BD31-4B8C-83A1-F6EECF244321}">
                      <p14:modId xmlns:p14="http://schemas.microsoft.com/office/powerpoint/2010/main" val="1191551680"/>
                    </p:ext>
                  </p:extLst>
                </p:nvPr>
              </p:nvGraphicFramePr>
              <p:xfrm>
                <a:off x="714375" y="3668172"/>
                <a:ext cx="5553075" cy="311705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20" name="TextBox 19"/>
                <p:cNvSpPr txBox="1"/>
                <p:nvPr/>
              </p:nvSpPr>
              <p:spPr>
                <a:xfrm>
                  <a:off x="1238250" y="4089654"/>
                  <a:ext cx="47641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abcd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1800225" y="4489704"/>
                  <a:ext cx="322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ac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2288801" y="4851654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bd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2784101" y="5366004"/>
                  <a:ext cx="33054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ab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276600" y="5689854"/>
                  <a:ext cx="33054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cd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3714750" y="4823079"/>
                  <a:ext cx="4587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fgh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4270001" y="5025905"/>
                  <a:ext cx="33054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g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4772025" y="5204079"/>
                  <a:ext cx="3129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fh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5257800" y="5604129"/>
                  <a:ext cx="30489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f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5746376" y="5721230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gh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6" name="Group 45"/>
              <p:cNvGrpSpPr/>
              <p:nvPr/>
            </p:nvGrpSpPr>
            <p:grpSpPr>
              <a:xfrm>
                <a:off x="728662" y="440530"/>
                <a:ext cx="5514976" cy="3119439"/>
                <a:chOff x="728662" y="440530"/>
                <a:chExt cx="5514976" cy="3119439"/>
              </a:xfrm>
            </p:grpSpPr>
            <p:graphicFrame>
              <p:nvGraphicFramePr>
                <p:cNvPr id="47" name="Chart 46"/>
                <p:cNvGraphicFramePr/>
                <p:nvPr>
                  <p:extLst>
                    <p:ext uri="{D42A27DB-BD31-4B8C-83A1-F6EECF244321}">
                      <p14:modId xmlns:p14="http://schemas.microsoft.com/office/powerpoint/2010/main" val="3707046524"/>
                    </p:ext>
                  </p:extLst>
                </p:nvPr>
              </p:nvGraphicFramePr>
              <p:xfrm>
                <a:off x="728662" y="440530"/>
                <a:ext cx="5514976" cy="311943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48" name="TextBox 47"/>
                <p:cNvSpPr txBox="1"/>
                <p:nvPr/>
              </p:nvSpPr>
              <p:spPr>
                <a:xfrm>
                  <a:off x="1409700" y="552450"/>
                  <a:ext cx="33054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ab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1866900" y="1057275"/>
                  <a:ext cx="33054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cd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381250" y="1485900"/>
                  <a:ext cx="2535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a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1" name="TextBox 50"/>
                <p:cNvSpPr txBox="1"/>
                <p:nvPr/>
              </p:nvSpPr>
              <p:spPr>
                <a:xfrm>
                  <a:off x="2819400" y="1943100"/>
                  <a:ext cx="33054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bc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3257550" y="2438400"/>
                  <a:ext cx="4074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abd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3800475" y="2438400"/>
                  <a:ext cx="2535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4276725" y="2495550"/>
                  <a:ext cx="2535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4733925" y="2524125"/>
                  <a:ext cx="2535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5219700" y="2543175"/>
                  <a:ext cx="2535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5695950" y="2619375"/>
                  <a:ext cx="2535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e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2" name="TextBox 1"/>
            <p:cNvSpPr txBox="1"/>
            <p:nvPr/>
          </p:nvSpPr>
          <p:spPr>
            <a:xfrm>
              <a:off x="3327864" y="3479102"/>
              <a:ext cx="6655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linity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333960" y="6655118"/>
              <a:ext cx="6655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linity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343796" y="7288899"/>
            <a:ext cx="570343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1 Fig. </a:t>
            </a:r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Plant biomass under salt stress. 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alt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stress-induced impairments on plant biomass (fresh weight and fry weight) and length of root and shoots of cumin seedlings under salinity 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tress. </a:t>
            </a:r>
            <a:r>
              <a:rPr lang="en-IN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Means ± SE followed by similar letters are significantly different at </a:t>
            </a:r>
            <a:r>
              <a:rPr lang="en-IN" sz="1600" i="1" dirty="0">
                <a:latin typeface="Times New Roman" panose="02020603050405020304" pitchFamily="18" charset="0"/>
                <a:ea typeface="Calibri" panose="020F0502020204030204" pitchFamily="34" charset="0"/>
              </a:rPr>
              <a:t>P</a:t>
            </a:r>
            <a:r>
              <a:rPr lang="en-IN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&lt;0.05</a:t>
            </a:r>
            <a:endParaRPr 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6</TotalTime>
  <Words>77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inash Mishra</dc:creator>
  <cp:lastModifiedBy>Avinash Mishra</cp:lastModifiedBy>
  <cp:revision>103</cp:revision>
  <dcterms:created xsi:type="dcterms:W3CDTF">2015-01-03T04:36:46Z</dcterms:created>
  <dcterms:modified xsi:type="dcterms:W3CDTF">2015-11-21T07:00:43Z</dcterms:modified>
</cp:coreProperties>
</file>